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  <p:sldId id="261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스타일 없음, 눈금 없음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2669" autoAdjust="0"/>
    <p:restoredTop sz="94660"/>
  </p:normalViewPr>
  <p:slideViewPr>
    <p:cSldViewPr snapToGrid="0" showGuides="1">
      <p:cViewPr>
        <p:scale>
          <a:sx n="166" d="100"/>
          <a:sy n="166" d="100"/>
        </p:scale>
        <p:origin x="1086" y="12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170003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71656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59486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59389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61722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126699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344269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19473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757803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38196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4079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F0F281-2DC7-4595-A58D-28E59F9040AC}" type="datetimeFigureOut">
              <a:rPr lang="ko-KR" altLang="en-US" smtClean="0"/>
              <a:t>2023-01-06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EA7A5F-29E5-478D-8583-D4B976383541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45924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5DBEE6C3-0333-053E-7829-54FBFA2557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03300985"/>
              </p:ext>
            </p:extLst>
          </p:nvPr>
        </p:nvGraphicFramePr>
        <p:xfrm>
          <a:off x="318603" y="607782"/>
          <a:ext cx="6220793" cy="11409196"/>
        </p:xfrm>
        <a:graphic>
          <a:graphicData uri="http://schemas.openxmlformats.org/drawingml/2006/table">
            <a:tbl>
              <a:tblPr/>
              <a:tblGrid>
                <a:gridCol w="420111">
                  <a:extLst>
                    <a:ext uri="{9D8B030D-6E8A-4147-A177-3AD203B41FA5}">
                      <a16:colId xmlns:a16="http://schemas.microsoft.com/office/drawing/2014/main" val="4158023893"/>
                    </a:ext>
                  </a:extLst>
                </a:gridCol>
                <a:gridCol w="2256718">
                  <a:extLst>
                    <a:ext uri="{9D8B030D-6E8A-4147-A177-3AD203B41FA5}">
                      <a16:colId xmlns:a16="http://schemas.microsoft.com/office/drawing/2014/main" val="2248045570"/>
                    </a:ext>
                  </a:extLst>
                </a:gridCol>
                <a:gridCol w="287250">
                  <a:extLst>
                    <a:ext uri="{9D8B030D-6E8A-4147-A177-3AD203B41FA5}">
                      <a16:colId xmlns:a16="http://schemas.microsoft.com/office/drawing/2014/main" val="3406288319"/>
                    </a:ext>
                  </a:extLst>
                </a:gridCol>
                <a:gridCol w="373426">
                  <a:extLst>
                    <a:ext uri="{9D8B030D-6E8A-4147-A177-3AD203B41FA5}">
                      <a16:colId xmlns:a16="http://schemas.microsoft.com/office/drawing/2014/main" val="2855516807"/>
                    </a:ext>
                  </a:extLst>
                </a:gridCol>
                <a:gridCol w="382405">
                  <a:extLst>
                    <a:ext uri="{9D8B030D-6E8A-4147-A177-3AD203B41FA5}">
                      <a16:colId xmlns:a16="http://schemas.microsoft.com/office/drawing/2014/main" val="3363164368"/>
                    </a:ext>
                  </a:extLst>
                </a:gridCol>
                <a:gridCol w="2118478">
                  <a:extLst>
                    <a:ext uri="{9D8B030D-6E8A-4147-A177-3AD203B41FA5}">
                      <a16:colId xmlns:a16="http://schemas.microsoft.com/office/drawing/2014/main" val="3759622044"/>
                    </a:ext>
                  </a:extLst>
                </a:gridCol>
                <a:gridCol w="382405">
                  <a:extLst>
                    <a:ext uri="{9D8B030D-6E8A-4147-A177-3AD203B41FA5}">
                      <a16:colId xmlns:a16="http://schemas.microsoft.com/office/drawing/2014/main" val="2504431365"/>
                    </a:ext>
                  </a:extLst>
                </a:gridCol>
              </a:tblGrid>
              <a:tr h="60514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430611"/>
                  </a:ext>
                </a:extLst>
              </a:tr>
              <a:tr h="6051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Up-regulated red mite pathways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altLang="ko-KR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own-regulated red mite pathways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625788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6883346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O ID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EGG pathway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#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O ID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EGG pathway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#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84374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pano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6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olysis / Gluconeogen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803733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line, leucine and isoleucine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5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ino sugar and nucleotide sugar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5543378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itrate cycle (TCA cycle)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imid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23621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popt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line, leucine and isoleucine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48548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1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utrophil extracellular trap form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tathio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6799320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1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NA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57338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iral carcinogen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ucleotide excision repai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971893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3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coh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4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ismatch repai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21906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olysis / Gluconeogen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anconi anemia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105222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uv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1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ermogen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585872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oxylate and dicarboxyl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 of neurodegeneration - multiple diseas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25143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ine, serine and threon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ructose and mannos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288221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ysine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uv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79549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7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hingolipid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oxylate and dicarboxyl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66080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sul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pano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569566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 - wor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ositol phosph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066130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icroRNAs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arbon fixation pathways in prokaryot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2397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teoglycans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tha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89680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5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ubercul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7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utin, suberine and wax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24773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3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ystemic lupus erythematosu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lipid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33314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41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ipid and atheroscler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3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phospholipid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596132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ur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9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achidonic acid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6319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yrimid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ur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345446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ginine and prol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ine, serine and threon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69126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yptophan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steine and methion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73324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eta-Alan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9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line, leucine and isoleucine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899814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One carbon pool by folat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ginine and prol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924940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ibo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4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O-Antigen nucleotide sugar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42986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1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NA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icotinate and nicotinamid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9670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rbB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ntothenate and CoA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436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5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I3K-Akt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6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cosinolate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838087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5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PK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8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rug metabolism - other enzym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6844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yso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NA polymer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1831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utophagy - animal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ibo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34256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poptosis - fl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NA replic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31413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cropt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omologous recombin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248176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5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ocal adhes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6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F-1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2229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5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ight jun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5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I3K-Akt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158189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OD-like recep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5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447479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 cell recep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uroactive ligand-receptor intera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85442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5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L-17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roxi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208672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urotroph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ll cycl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680854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emical carcinogenesis - reactive oxygen speci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1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ll cycle - yeast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6328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3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oline metabolism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1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iosis - yeast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28108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olorectal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ematopoietic cell lineag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96567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1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ndometrial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tosolic DNA-sens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74514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higell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sul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314334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4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agas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egulation of lipolysis in adipocyt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991097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3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heumatoid arthrit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yroid hormone 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307077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41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luid shear stress and atheroscler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ascular smooth muscle contra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448228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2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latinum drug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2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7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itamin digestion and absorp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32157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5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scorbate and aldar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etrograde endocannabinoid signaling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4729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5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utanoat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eurotroph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17490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07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atty acid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193073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10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teroid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ongevity regulating pathway - wor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28885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6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ycerolipid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erpes simplex virus 1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46067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59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rachidonic acid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zheimer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82908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2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ysteine and methion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yotrophic lateral scler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68345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stid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untington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36707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35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yrosi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2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GFR tyrosine kinase inhibitor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9175542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4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tathione metabolism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22915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7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ntothenate and CoA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550837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8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sect hormone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6058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0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imonene and pinene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47625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62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loroalkane and chloroalkene degrad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55956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09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inoacyl-tRNA biosynthe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873997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01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RNA surveillance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524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Ubiquitin mediated proteoly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39405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ismatch repai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83220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4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anconi anemia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87006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2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BC transporter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627572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APK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600059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APK signaling pathway - fl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46677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APK signaling pathway - yeast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162714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1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as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885240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Wnt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44579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9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ppo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344924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9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ppo signaling pathway - fl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934092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7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pel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687202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JAK-STAT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866264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6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NF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5571326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6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IF-1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883105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6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oxO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5905295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02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AMP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4817579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5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841851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51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ll adhesion molecul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23417308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ndocyt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989363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hago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7541506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785BC0D-B6AC-89A1-AADF-6C4B923715F5}"/>
              </a:ext>
            </a:extLst>
          </p:cNvPr>
          <p:cNvSpPr txBox="1"/>
          <p:nvPr/>
        </p:nvSpPr>
        <p:spPr>
          <a:xfrm>
            <a:off x="196930" y="152336"/>
            <a:ext cx="6094602" cy="455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5 Table. KEGG pathway of infected red mite DEGs.</a:t>
            </a:r>
            <a:endParaRPr lang="ko-KR" altLang="ko-KR" sz="1400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2602252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표 1">
            <a:extLst>
              <a:ext uri="{FF2B5EF4-FFF2-40B4-BE49-F238E27FC236}">
                <a16:creationId xmlns:a16="http://schemas.microsoft.com/office/drawing/2014/main" id="{5DBEE6C3-0333-053E-7829-54FBFA25573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20558921"/>
              </p:ext>
            </p:extLst>
          </p:nvPr>
        </p:nvGraphicFramePr>
        <p:xfrm>
          <a:off x="337456" y="493482"/>
          <a:ext cx="6220793" cy="9921040"/>
        </p:xfrm>
        <a:graphic>
          <a:graphicData uri="http://schemas.openxmlformats.org/drawingml/2006/table">
            <a:tbl>
              <a:tblPr/>
              <a:tblGrid>
                <a:gridCol w="420111">
                  <a:extLst>
                    <a:ext uri="{9D8B030D-6E8A-4147-A177-3AD203B41FA5}">
                      <a16:colId xmlns:a16="http://schemas.microsoft.com/office/drawing/2014/main" val="4158023893"/>
                    </a:ext>
                  </a:extLst>
                </a:gridCol>
                <a:gridCol w="2388199">
                  <a:extLst>
                    <a:ext uri="{9D8B030D-6E8A-4147-A177-3AD203B41FA5}">
                      <a16:colId xmlns:a16="http://schemas.microsoft.com/office/drawing/2014/main" val="2248045570"/>
                    </a:ext>
                  </a:extLst>
                </a:gridCol>
                <a:gridCol w="293298">
                  <a:extLst>
                    <a:ext uri="{9D8B030D-6E8A-4147-A177-3AD203B41FA5}">
                      <a16:colId xmlns:a16="http://schemas.microsoft.com/office/drawing/2014/main" val="3406288319"/>
                    </a:ext>
                  </a:extLst>
                </a:gridCol>
                <a:gridCol w="235897">
                  <a:extLst>
                    <a:ext uri="{9D8B030D-6E8A-4147-A177-3AD203B41FA5}">
                      <a16:colId xmlns:a16="http://schemas.microsoft.com/office/drawing/2014/main" val="2855516807"/>
                    </a:ext>
                  </a:extLst>
                </a:gridCol>
                <a:gridCol w="382405">
                  <a:extLst>
                    <a:ext uri="{9D8B030D-6E8A-4147-A177-3AD203B41FA5}">
                      <a16:colId xmlns:a16="http://schemas.microsoft.com/office/drawing/2014/main" val="3363164368"/>
                    </a:ext>
                  </a:extLst>
                </a:gridCol>
                <a:gridCol w="2118478">
                  <a:extLst>
                    <a:ext uri="{9D8B030D-6E8A-4147-A177-3AD203B41FA5}">
                      <a16:colId xmlns:a16="http://schemas.microsoft.com/office/drawing/2014/main" val="3759622044"/>
                    </a:ext>
                  </a:extLst>
                </a:gridCol>
                <a:gridCol w="382405">
                  <a:extLst>
                    <a:ext uri="{9D8B030D-6E8A-4147-A177-3AD203B41FA5}">
                      <a16:colId xmlns:a16="http://schemas.microsoft.com/office/drawing/2014/main" val="2504431365"/>
                    </a:ext>
                  </a:extLst>
                </a:gridCol>
              </a:tblGrid>
              <a:tr h="60514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26430611"/>
                  </a:ext>
                </a:extLst>
              </a:tr>
              <a:tr h="60514"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Up-regulated red mite pathways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6257881"/>
                  </a:ext>
                </a:extLst>
              </a:tr>
              <a:tr h="57635"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6883346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O ID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EGG pathway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eq#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0884374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4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roxisom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1803733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3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itophagy - animal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15543378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11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ll cycle - yeast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5123621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55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ignaling pathways regulating pluripotency of stem cell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848548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ll-like recep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6799320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ll and Imd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457338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-type lectin recep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72971893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ntigen processing and present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5221906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5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1 and Th2 cell differenti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97105222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59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17 cell differenti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3585872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6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 cell recepto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25143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6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Fc epsilon RI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288221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lucago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79549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33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PAR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66080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nRH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569566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stroge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066130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lact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92397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Oxytoc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89680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elaxin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324773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rowth hormone synthesis, secretion and a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333146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19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hyroid hormone signaling pathway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0596132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rathyroid hormone synthesis, secretion and a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716319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2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dosterone synthesis and secre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345446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26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drenergic signaling in cardiomyocyt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1869126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7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Vitamin digestion and absorp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6873324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dosterone-regulated sodium reabsorp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899814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72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Dopaminergic synap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924940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xon guid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642986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38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Osteoclast differenti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596701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62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lant-pathogen intera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436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ranscriptional misregulation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838087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0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emical carcinogenesis - receptor activa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6844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entral carbon metabolism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11831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3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D-L1 expression and PD-1 checkpoint pathway in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2634256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2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Gastric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631413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hronic myeloid leukemia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248176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1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Renal cell carcinoma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32229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1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rostate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7158189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2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reast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447479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mall cell lung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6585442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2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on-small cell lung cancer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7208672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uman T-cell leukemia virus 1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9680854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7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uman immunodeficiency virus 1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56328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epatitis B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28108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epatitis C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96567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7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oronavirus disease - COVID-19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74514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Measl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8314334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8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erpes simplex virus 1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991097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Kaposi sarcoma-associated herpesvirus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307077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9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pstein-Barr virus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4482285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6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Human papillomavirus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432157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2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pithelial cell signaling in Helicobacter pylori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747295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ogenic Escherichia coli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217490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almonella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193073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Yersinia infe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9228885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ertus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646067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34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egionell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682908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0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acterial invasion of epithelial cell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968345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45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oxoplasmo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30367070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1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Leishmaniasi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9175542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32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flammatory bowel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62291509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zheimer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55083713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rkinson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6058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17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Spinocerebellar ataxia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6476254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Pathways of neurodegeneration - multiple disease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49559562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Cocaine addi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873997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503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mphetamine addiction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30524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ype II diabetes mellitu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539405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40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Type I diabetes mellitu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83220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6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lcoholic liver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787006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Non-alcoholic fatty liver diseas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8627572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Insulin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86000597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493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GE-RAGE signaling pathway in diabetic complications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1466776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01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beta-Lactam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162714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23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Antifolate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68852401"/>
                  </a:ext>
                </a:extLst>
              </a:tr>
              <a:tr h="60514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01522 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Endocrine resistance 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ko-K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34" charset="-127"/>
                        </a:rPr>
                        <a:t>1</a:t>
                      </a: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ko-KR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34" charset="-127"/>
                      </a:endParaRPr>
                    </a:p>
                  </a:txBody>
                  <a:tcPr marL="2093" marR="2093" marT="209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66445799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9F86F63-6450-71E9-CEDC-3530A06BE9DF}"/>
              </a:ext>
            </a:extLst>
          </p:cNvPr>
          <p:cNvSpPr txBox="1"/>
          <p:nvPr/>
        </p:nvSpPr>
        <p:spPr>
          <a:xfrm>
            <a:off x="237187" y="152336"/>
            <a:ext cx="6094602" cy="4554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altLang="ko-KR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S5 Table.  </a:t>
            </a:r>
            <a:r>
              <a:rPr lang="en-US" altLang="ko-KR" sz="14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굴림" panose="020B0600000101010101" pitchFamily="50" charset="-127"/>
              </a:rPr>
              <a:t>Continued.</a:t>
            </a:r>
            <a:endParaRPr lang="ko-KR" altLang="ko-KR" sz="1400" i="1" dirty="0">
              <a:effectLst/>
              <a:latin typeface="굴림" panose="020B0600000101010101" pitchFamily="50" charset="-127"/>
              <a:ea typeface="굴림" panose="020B0600000101010101" pitchFamily="50" charset="-127"/>
              <a:cs typeface="굴림" panose="020B0600000101010101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3011212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8</TotalTime>
  <Words>1211</Words>
  <Application>Microsoft Office PowerPoint</Application>
  <PresentationFormat>와이드스크린</PresentationFormat>
  <Paragraphs>686</Paragraphs>
  <Slides>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8" baseType="lpstr">
      <vt:lpstr>굴림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소은</dc:creator>
  <cp:lastModifiedBy>jskim10@staff.jbnu.ac.kr</cp:lastModifiedBy>
  <cp:revision>7</cp:revision>
  <dcterms:created xsi:type="dcterms:W3CDTF">2022-09-14T06:04:29Z</dcterms:created>
  <dcterms:modified xsi:type="dcterms:W3CDTF">2023-01-06T05:28:07Z</dcterms:modified>
</cp:coreProperties>
</file>